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41813-BF9D-4BB0-95E5-1A48F285F7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7E105-687D-421D-9592-1E2318C7CB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0C981-8DE0-4006-A26C-3ED89BFAF3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40925-EEEC-4D36-B173-B5EF490432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AA74C-CFF2-4093-838E-5A20583702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C5CC0-D029-4F63-AEB3-5B0B630D0F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C1E1C-C137-4B0B-A43E-F58CA20619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2A6D3-3413-4EE5-B1A7-910C7E0476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F6CCF-D8EF-4717-AC2C-DF5B85C9F5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2DBB7-9105-49B0-8A9B-B50BA053F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B36CE-5639-4A31-8522-D499F351BC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4F657-8BC3-476E-8EF4-18D5EBB58A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05F0DE-6100-4C03-ACE2-E47EF815A805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684360" y="620640"/>
            <a:ext cx="3919320" cy="3600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4859280" y="620640"/>
            <a:ext cx="3247920" cy="28796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"/>
          <p:cNvPicPr/>
          <p:nvPr/>
        </p:nvPicPr>
        <p:blipFill>
          <a:blip r:embed="rId3"/>
          <a:stretch/>
        </p:blipFill>
        <p:spPr>
          <a:xfrm>
            <a:off x="5003640" y="3573360"/>
            <a:ext cx="3311640" cy="2880000"/>
          </a:xfrm>
          <a:prstGeom prst="rect">
            <a:avLst/>
          </a:prstGeom>
          <a:ln w="0">
            <a:noFill/>
          </a:ln>
        </p:spPr>
      </p:pic>
      <p:sp>
        <p:nvSpPr>
          <p:cNvPr id="44" name="Text Box 33"/>
          <p:cNvSpPr/>
          <p:nvPr/>
        </p:nvSpPr>
        <p:spPr>
          <a:xfrm>
            <a:off x="826920" y="4195080"/>
            <a:ext cx="367380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. Sequence alignment between authentic 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genomic clones from rye IR27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3, 5, 6: AB124641, 124643, 124644)  and newly isolate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genomic clones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3 on Chr. 6R,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5 on Chr. 1R,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6 on Chr. 5R: AB646252-646254) from each rye Imperial chromosome added in whea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Each genomic clone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localized on the chromosomes exhibits homology of 96~98% between the genomes of IR27 and Imperial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1206720" y="260280"/>
            <a:ext cx="2942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3 on Chr. 6R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テキスト ボックス 8"/>
          <p:cNvSpPr/>
          <p:nvPr/>
        </p:nvSpPr>
        <p:spPr>
          <a:xfrm>
            <a:off x="5077800" y="260280"/>
            <a:ext cx="2942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5 on Chr. 1R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テキスト ボックス 9"/>
          <p:cNvSpPr/>
          <p:nvPr/>
        </p:nvSpPr>
        <p:spPr>
          <a:xfrm>
            <a:off x="5150160" y="3213000"/>
            <a:ext cx="2942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6 on Chr. 5R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テキスト ボックス 10"/>
          <p:cNvSpPr/>
          <p:nvPr/>
        </p:nvSpPr>
        <p:spPr>
          <a:xfrm rot="16200000">
            <a:off x="-392760" y="1911960"/>
            <a:ext cx="1747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3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テキスト ボックス 11"/>
          <p:cNvSpPr/>
          <p:nvPr/>
        </p:nvSpPr>
        <p:spPr>
          <a:xfrm rot="16200000">
            <a:off x="3970440" y="1769040"/>
            <a:ext cx="1520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テキスト ボックス 12"/>
          <p:cNvSpPr/>
          <p:nvPr/>
        </p:nvSpPr>
        <p:spPr>
          <a:xfrm rot="16200000">
            <a:off x="3970440" y="4721040"/>
            <a:ext cx="1520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Revolver-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04-03-18T13:59:44Z</dcterms:created>
  <dc:creator>富田因則</dc:creator>
  <dc:description/>
  <dc:language>en-US</dc:language>
  <cp:lastModifiedBy>Owner</cp:lastModifiedBy>
  <dcterms:modified xsi:type="dcterms:W3CDTF">2011-09-22T07:10:31Z</dcterms:modified>
  <cp:revision>11</cp:revision>
  <dc:subject/>
  <dc:title>PowerPoint プレゼンテーション</dc:title>
</cp:coreProperties>
</file>